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0" autoAdjust="0"/>
    <p:restoredTop sz="94660"/>
  </p:normalViewPr>
  <p:slideViewPr>
    <p:cSldViewPr snapToGrid="0">
      <p:cViewPr varScale="1">
        <p:scale>
          <a:sx n="69" d="100"/>
          <a:sy n="69" d="100"/>
        </p:scale>
        <p:origin x="560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47BCB-1DBE-4A9F-AD60-F943911D1BD9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67158-4608-4D0F-89D2-493CA6C61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60217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47BCB-1DBE-4A9F-AD60-F943911D1BD9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67158-4608-4D0F-89D2-493CA6C61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3928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47BCB-1DBE-4A9F-AD60-F943911D1BD9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67158-4608-4D0F-89D2-493CA6C61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24576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47BCB-1DBE-4A9F-AD60-F943911D1BD9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67158-4608-4D0F-89D2-493CA6C61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63503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47BCB-1DBE-4A9F-AD60-F943911D1BD9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67158-4608-4D0F-89D2-493CA6C61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84520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47BCB-1DBE-4A9F-AD60-F943911D1BD9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67158-4608-4D0F-89D2-493CA6C61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8248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47BCB-1DBE-4A9F-AD60-F943911D1BD9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67158-4608-4D0F-89D2-493CA6C61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38387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47BCB-1DBE-4A9F-AD60-F943911D1BD9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67158-4608-4D0F-89D2-493CA6C61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40713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47BCB-1DBE-4A9F-AD60-F943911D1BD9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67158-4608-4D0F-89D2-493CA6C61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94834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47BCB-1DBE-4A9F-AD60-F943911D1BD9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67158-4608-4D0F-89D2-493CA6C61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63587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47BCB-1DBE-4A9F-AD60-F943911D1BD9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67158-4608-4D0F-89D2-493CA6C61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51521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347BCB-1DBE-4A9F-AD60-F943911D1BD9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C67158-4608-4D0F-89D2-493CA6C61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69092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27761933"/>
              </p:ext>
            </p:extLst>
          </p:nvPr>
        </p:nvGraphicFramePr>
        <p:xfrm>
          <a:off x="890754" y="464455"/>
          <a:ext cx="9516774" cy="5056977"/>
        </p:xfrm>
        <a:graphic>
          <a:graphicData uri="http://schemas.openxmlformats.org/drawingml/2006/table">
            <a:tbl>
              <a:tblPr firstRow="1" firstCol="1" bandRow="1"/>
              <a:tblGrid>
                <a:gridCol w="5029755">
                  <a:extLst>
                    <a:ext uri="{9D8B030D-6E8A-4147-A177-3AD203B41FA5}">
                      <a16:colId xmlns:a16="http://schemas.microsoft.com/office/drawing/2014/main" val="1761102054"/>
                    </a:ext>
                  </a:extLst>
                </a:gridCol>
                <a:gridCol w="1308230">
                  <a:extLst>
                    <a:ext uri="{9D8B030D-6E8A-4147-A177-3AD203B41FA5}">
                      <a16:colId xmlns:a16="http://schemas.microsoft.com/office/drawing/2014/main" val="4164890155"/>
                    </a:ext>
                  </a:extLst>
                </a:gridCol>
                <a:gridCol w="1728372">
                  <a:extLst>
                    <a:ext uri="{9D8B030D-6E8A-4147-A177-3AD203B41FA5}">
                      <a16:colId xmlns:a16="http://schemas.microsoft.com/office/drawing/2014/main" val="2973888933"/>
                    </a:ext>
                  </a:extLst>
                </a:gridCol>
                <a:gridCol w="1450417">
                  <a:extLst>
                    <a:ext uri="{9D8B030D-6E8A-4147-A177-3AD203B41FA5}">
                      <a16:colId xmlns:a16="http://schemas.microsoft.com/office/drawing/2014/main" val="3448796862"/>
                    </a:ext>
                  </a:extLst>
                </a:gridCol>
              </a:tblGrid>
              <a:tr h="570018">
                <a:tc>
                  <a:txBody>
                    <a:bodyPr/>
                    <a:lstStyle/>
                    <a:p>
                      <a:endParaRPr lang="en-US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dirty="0" smtClean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ercentage (N=96)</a:t>
                      </a:r>
                      <a:endParaRPr lang="en-US" sz="1600" b="1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dirty="0" smtClean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umber</a:t>
                      </a:r>
                      <a:endParaRPr lang="en-US" sz="1600" b="1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93348718"/>
                  </a:ext>
                </a:extLst>
              </a:tr>
              <a:tr h="363195"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</a:t>
                      </a:r>
                    </a:p>
                    <a:p>
                      <a:endParaRPr lang="en-US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3.8%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2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60702147"/>
                  </a:ext>
                </a:extLst>
              </a:tr>
              <a:tr h="361349"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normal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2.1%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0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8884738"/>
                  </a:ext>
                </a:extLst>
              </a:tr>
              <a:tr h="341745"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orderline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.2%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35678660"/>
                  </a:ext>
                </a:extLst>
              </a:tr>
              <a:tr h="560441">
                <a:tc>
                  <a:txBody>
                    <a:bodyPr/>
                    <a:lstStyle/>
                    <a:p>
                      <a:endParaRPr lang="en-US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umber</a:t>
                      </a:r>
                      <a:endParaRPr lang="en-US" sz="16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% of all Abnormal </a:t>
                      </a:r>
                      <a:r>
                        <a:rPr lang="en-US" sz="1600" b="1" dirty="0" smtClean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CGs (N=54)</a:t>
                      </a:r>
                      <a:endParaRPr lang="en-US" sz="16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% of All </a:t>
                      </a:r>
                      <a:r>
                        <a:rPr lang="en-US" sz="1600" b="1" dirty="0" smtClean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CGs</a:t>
                      </a: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dirty="0" smtClean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N=96)</a:t>
                      </a:r>
                      <a:endParaRPr lang="en-US" sz="16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87309040"/>
                  </a:ext>
                </a:extLst>
              </a:tr>
              <a:tr h="22861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onduction</a:t>
                      </a:r>
                      <a:r>
                        <a:rPr lang="en-US" sz="1400" b="0" baseline="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Abnormality</a:t>
                      </a:r>
                      <a:endParaRPr lang="en-US" sz="14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1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2.7%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00290326"/>
                  </a:ext>
                </a:extLst>
              </a:tr>
              <a:tr h="22861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  Nonspecific </a:t>
                      </a:r>
                      <a:r>
                        <a:rPr lang="en-US" sz="1400" b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ntraventricular Conduction Delay</a:t>
                      </a:r>
                      <a:endParaRPr lang="en-US" sz="14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7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8.5%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8.5%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56219072"/>
                  </a:ext>
                </a:extLst>
              </a:tr>
              <a:tr h="22861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Right Axis</a:t>
                      </a:r>
                      <a:r>
                        <a:rPr lang="en-US" sz="1400" b="0" baseline="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Deviation</a:t>
                      </a:r>
                      <a:endParaRPr lang="en-US" sz="14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.3%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.2%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2516054"/>
                  </a:ext>
                </a:extLst>
              </a:tr>
              <a:tr h="22861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Nonspecific ST and T</a:t>
                      </a:r>
                      <a:r>
                        <a:rPr lang="en-US" sz="1400" b="0" baseline="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Wave Abnormality</a:t>
                      </a:r>
                      <a:endParaRPr lang="en-US" sz="14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6.7%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.4%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3137148"/>
                  </a:ext>
                </a:extLst>
              </a:tr>
              <a:tr h="22861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  Right Bundle Branch </a:t>
                      </a:r>
                      <a:r>
                        <a:rPr lang="en-US" sz="1400" b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lock</a:t>
                      </a:r>
                      <a:endParaRPr lang="en-US" sz="14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.7%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.1%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00578704"/>
                  </a:ext>
                </a:extLst>
              </a:tr>
              <a:tr h="22861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Sinus Arrhythmia</a:t>
                      </a:r>
                      <a:endParaRPr lang="en-US" sz="14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9%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0%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63185733"/>
                  </a:ext>
                </a:extLst>
              </a:tr>
              <a:tr h="22861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  Incomplete </a:t>
                      </a:r>
                      <a:r>
                        <a:rPr lang="en-US" sz="1400" b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ight </a:t>
                      </a:r>
                      <a:r>
                        <a:rPr lang="en-US" sz="1400" b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undle Branch </a:t>
                      </a:r>
                      <a:r>
                        <a:rPr lang="en-US" sz="1400" b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lock</a:t>
                      </a:r>
                      <a:endParaRPr lang="en-US" sz="14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9%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0%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38969188"/>
                  </a:ext>
                </a:extLst>
              </a:tr>
              <a:tr h="22861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baseline="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Early Repolarization</a:t>
                      </a:r>
                      <a:endParaRPr lang="en-US" sz="14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7%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1%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03042342"/>
                  </a:ext>
                </a:extLst>
              </a:tr>
              <a:tr h="22861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Ventricular</a:t>
                      </a:r>
                      <a:r>
                        <a:rPr lang="en-US" sz="1400" b="0" baseline="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Premature Complex</a:t>
                      </a:r>
                      <a:endParaRPr lang="en-US" sz="14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7%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1%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4585976"/>
                  </a:ext>
                </a:extLst>
              </a:tr>
              <a:tr h="287894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  Left Posterior Fascicular</a:t>
                      </a:r>
                      <a:r>
                        <a:rPr lang="en-US" sz="1400" b="0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Block</a:t>
                      </a:r>
                      <a:endParaRPr lang="en-US" sz="14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9%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0%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46231982"/>
                  </a:ext>
                </a:extLst>
              </a:tr>
              <a:tr h="247983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  Atrial Premature Complex</a:t>
                      </a:r>
                      <a:endParaRPr lang="en-US" sz="14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9%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0%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4442184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358996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134</Words>
  <Application>Microsoft Office PowerPoint</Application>
  <PresentationFormat>Widescreen</PresentationFormat>
  <Paragraphs>5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CSF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ou, Samuel</dc:creator>
  <cp:lastModifiedBy>Kou, Samuel</cp:lastModifiedBy>
  <cp:revision>3</cp:revision>
  <dcterms:created xsi:type="dcterms:W3CDTF">2020-02-08T22:10:53Z</dcterms:created>
  <dcterms:modified xsi:type="dcterms:W3CDTF">2020-02-08T23:33:22Z</dcterms:modified>
</cp:coreProperties>
</file>